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99"/>
    <a:srgbClr val="148A14"/>
    <a:srgbClr val="000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26B93A-8ADC-4742-B008-93A6E9E4CC49}" v="20" dt="2023-11-18T11:01:07.7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526" autoAdjust="0"/>
    <p:restoredTop sz="93447" autoAdjust="0"/>
  </p:normalViewPr>
  <p:slideViewPr>
    <p:cSldViewPr snapToGrid="0">
      <p:cViewPr varScale="1">
        <p:scale>
          <a:sx n="74" d="100"/>
          <a:sy n="74" d="100"/>
        </p:scale>
        <p:origin x="66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4000D6-3CE9-45CC-E21A-40F8D7AB7F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2C9CA78-D715-AF3A-91B0-4BEF4B5543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96C9724-C036-C6E2-D79C-23BB7D0DC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5B30E9-F797-7B34-A94C-07725994E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178A86-C407-AFB3-E64A-8582D6D8D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7246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E90ABA8-1412-89B2-ABCB-EAE2C5A23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BF51F72-0BB8-FB0E-ABD5-1A6D4F5392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4BA20CF-DF1E-0888-923C-E17FD64CB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62CF077-0F4B-167E-9073-EC0DAEF7E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B762978-A959-AD73-4A5A-87883D561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8099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0E82F34-8A61-F0FE-DEBA-93735E838F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FC45139-4B45-3680-8739-2BBD45749F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3D89EF-B2BB-354A-6EFA-168B79961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0AC15E-D7A6-2B0A-21E8-6A67C659D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78FB331-838E-03EB-A051-C68F61401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7293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F81DDCC-E9E6-9206-7CDA-009F7A77B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4852E97-7F5C-D54C-C9DB-D7A4E05F2A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C0E733-D5DE-1263-7052-723719153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367455-05A3-21B5-49A9-E8E25556E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5D9BEF7-FB2B-F2DF-E852-787128430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4794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4DD7F7-9825-15D4-80A4-E2F5011C2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A09852F-CB19-D2DA-97E3-BBD6776098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84BEDF1-E0FB-0960-8CF5-FDEBC6192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ABE5BFA-2885-1DEA-557F-0D3D49699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A26CBB-E331-C73C-4E7F-DC1BA580E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0736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41F17A-C6A1-BB1A-9328-9BE398DBFC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8965219-A656-6878-4F2C-AE9A515E69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E453CE8-5086-D68F-9891-321F1B644E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94C8C4E-A753-F2D6-5E32-80B788F2A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04D9BC8-37D4-B8FD-8881-1FA96633B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750506-9F40-AEC0-CFBA-A4549F5EC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938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035215-07BE-DB13-9E52-E3855A064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0DA8C49-F4D9-9038-31BC-A4B03F5179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E5EE543-57EC-1B31-3BB6-B96A1E5966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8F003FF-EEE3-AE7B-6A5E-53CD9E23E0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D58DA49-99C1-A554-5D0C-916848EC0D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9DABDBB-2265-FA9C-6ABC-1550137A9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A7C5694-85F5-A407-4240-48CFC76BB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CF9D732-ADE3-B209-8603-ED2B5FAFE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7807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0D95D0-3EFE-C14E-1469-83D339C8F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4CC925D-B266-F516-DFEB-762E9A673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270C995-EEFA-CD34-E990-3A9A7FE72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17E659B-C3B0-1C0B-3A38-4F4B87FD4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993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E73473A-66BA-5132-98B0-57BAF21E0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4C2F872-E1EB-7473-56D6-A8055FEE0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1CF86E6-B46D-3DCB-B0D5-6F367F570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004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FD1CA6-F0AB-8303-1AA9-50964B52D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541E87F-0099-FD06-0DB4-673656E05E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C7D1C64-6EC2-FEB4-0569-50ED350983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25748FE-8AD6-1925-7C92-AF8555C48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7F2949C-1297-4415-04C8-30DA9A288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E85C0CC-D57F-3DEB-61B5-71CE64821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9101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895689-17BC-06E3-0B69-FBCB05307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EFBA5D1-D841-451B-ACAE-B264EEC912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FF7B94D-0244-2902-B04B-C6BC8FF28C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AB202C4-7099-AE81-DAF4-8B00463D6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60D8036-F4B1-976A-8862-908FE3553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179379C-5FB0-C548-3EAB-A340221A6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1440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58F8E52-0C2C-F58A-2B4D-A08F8814F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38F5A35-5800-55CC-61A7-8565E117B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21C7AF-E313-8FB2-BF79-5A53FF2DE3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BA9D-1408-41B8-8A45-A536E8BA0C33}" type="datetimeFigureOut">
              <a:rPr lang="it-IT" smtClean="0"/>
              <a:t>03/01/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476431-1089-352C-7708-BE74A3B87B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45ADF41-0E0F-1F9A-268C-C7ED11F3D6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8A2B4-E065-46BA-8278-1BAF4FCD09C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6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4C2889D0-7F3D-D113-B9F2-3A08A20416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094" y="1461220"/>
            <a:ext cx="5724525" cy="4295775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BE5C44C5-0CF2-F3B8-CC67-1EA393DFBC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68968" y="1451080"/>
            <a:ext cx="5724525" cy="4295775"/>
          </a:xfrm>
          <a:prstGeom prst="rect">
            <a:avLst/>
          </a:prstGeom>
        </p:spPr>
      </p:pic>
      <p:sp>
        <p:nvSpPr>
          <p:cNvPr id="8" name="object 84">
            <a:extLst>
              <a:ext uri="{FF2B5EF4-FFF2-40B4-BE49-F238E27FC236}">
                <a16:creationId xmlns:a16="http://schemas.microsoft.com/office/drawing/2014/main" id="{F9CBB2AF-EF11-568A-A1A4-B82E404C02EC}"/>
              </a:ext>
            </a:extLst>
          </p:cNvPr>
          <p:cNvSpPr txBox="1"/>
          <p:nvPr/>
        </p:nvSpPr>
        <p:spPr>
          <a:xfrm>
            <a:off x="11068111" y="1560223"/>
            <a:ext cx="1683412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78.2 (54.6-96.1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6830">
              <a:lnSpc>
                <a:spcPct val="100000"/>
              </a:lnSpc>
              <a:spcBef>
                <a:spcPts val="105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30.8 (26.2-35.9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object 85">
            <a:extLst>
              <a:ext uri="{FF2B5EF4-FFF2-40B4-BE49-F238E27FC236}">
                <a16:creationId xmlns:a16="http://schemas.microsoft.com/office/drawing/2014/main" id="{73AD58C9-E033-D7E7-D7EB-D159C51105BF}"/>
              </a:ext>
            </a:extLst>
          </p:cNvPr>
          <p:cNvSpPr txBox="1"/>
          <p:nvPr/>
        </p:nvSpPr>
        <p:spPr>
          <a:xfrm>
            <a:off x="10372664" y="1565203"/>
            <a:ext cx="536604" cy="328935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 algn="ctr">
              <a:spcBef>
                <a:spcPts val="204"/>
              </a:spcBef>
            </a:pPr>
            <a:r>
              <a:rPr lang="it-IT" sz="900" spc="50" dirty="0">
                <a:latin typeface="Arial" panose="020B0604020202020204" pitchFamily="34" charset="0"/>
                <a:cs typeface="Arial" panose="020B0604020202020204" pitchFamily="34" charset="0"/>
              </a:rPr>
              <a:t>33/58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algn="ctr">
              <a:lnSpc>
                <a:spcPct val="100000"/>
              </a:lnSpc>
              <a:spcBef>
                <a:spcPts val="204"/>
              </a:spcBef>
            </a:pPr>
            <a:r>
              <a:rPr lang="it-IT" sz="900" spc="50" dirty="0">
                <a:latin typeface="Arial" panose="020B0604020202020204" pitchFamily="34" charset="0"/>
                <a:cs typeface="Arial" panose="020B0604020202020204" pitchFamily="34" charset="0"/>
              </a:rPr>
              <a:t>93/149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object 87">
            <a:extLst>
              <a:ext uri="{FF2B5EF4-FFF2-40B4-BE49-F238E27FC236}">
                <a16:creationId xmlns:a16="http://schemas.microsoft.com/office/drawing/2014/main" id="{DC916019-130B-3E9F-993B-226AD2AD4793}"/>
              </a:ext>
            </a:extLst>
          </p:cNvPr>
          <p:cNvSpPr txBox="1"/>
          <p:nvPr/>
        </p:nvSpPr>
        <p:spPr>
          <a:xfrm>
            <a:off x="8184233" y="1572678"/>
            <a:ext cx="2980559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15" dirty="0">
                <a:latin typeface="Arial" panose="020B0604020202020204" pitchFamily="34" charset="0"/>
                <a:cs typeface="Arial" panose="020B0604020202020204" pitchFamily="34" charset="0"/>
              </a:rPr>
              <a:t>     Late relapse</a:t>
            </a:r>
            <a:r>
              <a:rPr sz="900" spc="1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spc="15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it-IT" sz="900" spc="3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sz="900" spc="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(0.</a:t>
            </a:r>
            <a:r>
              <a:rPr lang="it-IT" sz="900" spc="30" dirty="0">
                <a:latin typeface="Arial" panose="020B0604020202020204" pitchFamily="34" charset="0"/>
                <a:cs typeface="Arial" panose="020B0604020202020204" pitchFamily="34" charset="0"/>
              </a:rPr>
              <a:t>21-0,44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105"/>
              </a:spcBef>
              <a:tabLst>
                <a:tab pos="286385" algn="l"/>
              </a:tabLst>
            </a:pPr>
            <a:r>
              <a:rPr lang="it-IT" sz="900" spc="25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it-IT" sz="900" spc="25" dirty="0" err="1">
                <a:latin typeface="Arial" panose="020B0604020202020204" pitchFamily="34" charset="0"/>
                <a:cs typeface="Arial" panose="020B0604020202020204" pitchFamily="34" charset="0"/>
              </a:rPr>
              <a:t>Early</a:t>
            </a:r>
            <a:r>
              <a:rPr lang="it-IT" sz="900" spc="25" dirty="0">
                <a:latin typeface="Arial" panose="020B0604020202020204" pitchFamily="34" charset="0"/>
                <a:cs typeface="Arial" panose="020B0604020202020204" pitchFamily="34" charset="0"/>
              </a:rPr>
              <a:t> relapse         </a:t>
            </a:r>
            <a:r>
              <a:rPr sz="900" spc="5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eference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object 88">
            <a:extLst>
              <a:ext uri="{FF2B5EF4-FFF2-40B4-BE49-F238E27FC236}">
                <a16:creationId xmlns:a16="http://schemas.microsoft.com/office/drawing/2014/main" id="{93BFFB8D-887E-F90D-727F-ABBE8FF04814}"/>
              </a:ext>
            </a:extLst>
          </p:cNvPr>
          <p:cNvSpPr txBox="1"/>
          <p:nvPr/>
        </p:nvSpPr>
        <p:spPr>
          <a:xfrm>
            <a:off x="8367536" y="1385080"/>
            <a:ext cx="4010256" cy="153888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</a:t>
            </a:r>
            <a:r>
              <a:rPr sz="9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9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5B45AF08-88B6-F7D8-9F0D-DA0E19C935A6}"/>
              </a:ext>
            </a:extLst>
          </p:cNvPr>
          <p:cNvSpPr txBox="1"/>
          <p:nvPr/>
        </p:nvSpPr>
        <p:spPr>
          <a:xfrm>
            <a:off x="11164792" y="1966982"/>
            <a:ext cx="13362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1" spc="30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it-IT" sz="1100" dirty="0"/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99061D5F-2798-C03B-A8D1-D9A721A13065}"/>
              </a:ext>
            </a:extLst>
          </p:cNvPr>
          <p:cNvSpPr txBox="1"/>
          <p:nvPr/>
        </p:nvSpPr>
        <p:spPr>
          <a:xfrm>
            <a:off x="434803" y="1188666"/>
            <a:ext cx="32490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1" spc="3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100" dirty="0"/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B78714C2-E11F-FF7D-EE22-58F1D9CCAB84}"/>
              </a:ext>
            </a:extLst>
          </p:cNvPr>
          <p:cNvSpPr txBox="1"/>
          <p:nvPr/>
        </p:nvSpPr>
        <p:spPr>
          <a:xfrm>
            <a:off x="6305209" y="1199610"/>
            <a:ext cx="32490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1" spc="3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100" dirty="0"/>
          </a:p>
        </p:txBody>
      </p:sp>
      <p:sp>
        <p:nvSpPr>
          <p:cNvPr id="23" name="object 84">
            <a:extLst>
              <a:ext uri="{FF2B5EF4-FFF2-40B4-BE49-F238E27FC236}">
                <a16:creationId xmlns:a16="http://schemas.microsoft.com/office/drawing/2014/main" id="{91468833-8681-5D1A-3BF0-FDF983D1948E}"/>
              </a:ext>
            </a:extLst>
          </p:cNvPr>
          <p:cNvSpPr txBox="1"/>
          <p:nvPr/>
        </p:nvSpPr>
        <p:spPr>
          <a:xfrm>
            <a:off x="4955010" y="1548475"/>
            <a:ext cx="1683412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60.0 (47.7-81.0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6830">
              <a:lnSpc>
                <a:spcPct val="100000"/>
              </a:lnSpc>
              <a:spcBef>
                <a:spcPts val="105"/>
              </a:spcBef>
            </a:pPr>
            <a:r>
              <a:rPr lang="it-IT" sz="900" spc="20" dirty="0">
                <a:latin typeface="Arial" panose="020B0604020202020204" pitchFamily="34" charset="0"/>
                <a:cs typeface="Arial" panose="020B0604020202020204" pitchFamily="34" charset="0"/>
              </a:rPr>
              <a:t>27.1 (24.2-74.7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object 87">
            <a:extLst>
              <a:ext uri="{FF2B5EF4-FFF2-40B4-BE49-F238E27FC236}">
                <a16:creationId xmlns:a16="http://schemas.microsoft.com/office/drawing/2014/main" id="{89B35B09-ED28-06E8-BD0A-B97EACD2106D}"/>
              </a:ext>
            </a:extLst>
          </p:cNvPr>
          <p:cNvSpPr txBox="1"/>
          <p:nvPr/>
        </p:nvSpPr>
        <p:spPr>
          <a:xfrm>
            <a:off x="2110042" y="1560930"/>
            <a:ext cx="2980559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4"/>
              </a:spcBef>
            </a:pPr>
            <a:r>
              <a:rPr lang="it-IT" sz="900" spc="15" dirty="0">
                <a:latin typeface="Arial" panose="020B0604020202020204" pitchFamily="34" charset="0"/>
                <a:cs typeface="Arial" panose="020B0604020202020204" pitchFamily="34" charset="0"/>
              </a:rPr>
              <a:t>     Late relapse</a:t>
            </a:r>
            <a:r>
              <a:rPr sz="900" spc="1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spc="15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it-IT" sz="900" spc="30" dirty="0">
                <a:latin typeface="Arial" panose="020B0604020202020204" pitchFamily="34" charset="0"/>
                <a:cs typeface="Arial" panose="020B0604020202020204" pitchFamily="34" charset="0"/>
              </a:rPr>
              <a:t>20 (0.13-0.31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105"/>
              </a:spcBef>
              <a:tabLst>
                <a:tab pos="286385" algn="l"/>
              </a:tabLst>
            </a:pPr>
            <a:r>
              <a:rPr lang="it-IT" sz="900" spc="25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it-IT" sz="900" spc="25" dirty="0" err="1">
                <a:latin typeface="Arial" panose="020B0604020202020204" pitchFamily="34" charset="0"/>
                <a:cs typeface="Arial" panose="020B0604020202020204" pitchFamily="34" charset="0"/>
              </a:rPr>
              <a:t>Early</a:t>
            </a:r>
            <a:r>
              <a:rPr lang="it-IT" sz="900" spc="25" dirty="0">
                <a:latin typeface="Arial" panose="020B0604020202020204" pitchFamily="34" charset="0"/>
                <a:cs typeface="Arial" panose="020B0604020202020204" pitchFamily="34" charset="0"/>
              </a:rPr>
              <a:t> relapse         </a:t>
            </a:r>
            <a:r>
              <a:rPr sz="900" spc="5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sz="900" spc="30" dirty="0">
                <a:latin typeface="Arial" panose="020B0604020202020204" pitchFamily="34" charset="0"/>
                <a:cs typeface="Arial" panose="020B0604020202020204" pitchFamily="34" charset="0"/>
              </a:rPr>
              <a:t>eference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object 88">
            <a:extLst>
              <a:ext uri="{FF2B5EF4-FFF2-40B4-BE49-F238E27FC236}">
                <a16:creationId xmlns:a16="http://schemas.microsoft.com/office/drawing/2014/main" id="{7BC923B8-8BCA-01E4-44E8-5413C76ADCFB}"/>
              </a:ext>
            </a:extLst>
          </p:cNvPr>
          <p:cNvSpPr txBox="1"/>
          <p:nvPr/>
        </p:nvSpPr>
        <p:spPr>
          <a:xfrm>
            <a:off x="2293346" y="1373332"/>
            <a:ext cx="4010256" cy="153888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  <a:tabLst>
                <a:tab pos="353695" algn="l"/>
                <a:tab pos="871855" algn="l"/>
              </a:tabLst>
            </a:pPr>
            <a:r>
              <a:rPr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Group</a:t>
            </a:r>
            <a:r>
              <a:rPr lang="it-IT" sz="900" b="1" spc="35" dirty="0">
                <a:latin typeface="Arial" panose="020B0604020202020204" pitchFamily="34" charset="0"/>
                <a:cs typeface="Arial" panose="020B0604020202020204" pitchFamily="34" charset="0"/>
              </a:rPr>
              <a:t>                 </a:t>
            </a:r>
            <a:r>
              <a:rPr sz="900" b="1" spc="15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sz="900" b="1" spc="10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r>
              <a:rPr lang="it-IT"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r>
              <a:rPr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/Total </a:t>
            </a:r>
            <a:r>
              <a:rPr lang="it-IT" sz="900" b="1" spc="1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30" dirty="0">
                <a:latin typeface="Arial" panose="020B0604020202020204" pitchFamily="34" charset="0"/>
                <a:cs typeface="Arial" panose="020B0604020202020204" pitchFamily="34" charset="0"/>
              </a:rPr>
              <a:t>Median </a:t>
            </a:r>
            <a:r>
              <a:rPr sz="900" b="1" spc="40" dirty="0">
                <a:latin typeface="Arial" panose="020B0604020202020204" pitchFamily="34" charset="0"/>
                <a:cs typeface="Arial" panose="020B0604020202020204" pitchFamily="34" charset="0"/>
              </a:rPr>
              <a:t>(95%</a:t>
            </a:r>
            <a:r>
              <a:rPr sz="900" b="1" spc="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900" b="1" spc="20" dirty="0">
                <a:latin typeface="Arial" panose="020B0604020202020204" pitchFamily="34" charset="0"/>
                <a:cs typeface="Arial" panose="020B0604020202020204" pitchFamily="34" charset="0"/>
              </a:rPr>
              <a:t>CI)</a:t>
            </a:r>
            <a:endParaRPr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40FEF7BC-6822-D71D-A1F8-ED84B8AF442B}"/>
              </a:ext>
            </a:extLst>
          </p:cNvPr>
          <p:cNvSpPr txBox="1"/>
          <p:nvPr/>
        </p:nvSpPr>
        <p:spPr>
          <a:xfrm>
            <a:off x="5073063" y="1957741"/>
            <a:ext cx="13362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100" b="1" spc="30" dirty="0">
                <a:latin typeface="Arial" panose="020B0604020202020204" pitchFamily="34" charset="0"/>
                <a:cs typeface="Arial" panose="020B0604020202020204" pitchFamily="34" charset="0"/>
              </a:rPr>
              <a:t>p &lt; 0.0001</a:t>
            </a:r>
            <a:endParaRPr lang="it-IT" sz="1100" dirty="0"/>
          </a:p>
        </p:txBody>
      </p:sp>
      <p:cxnSp>
        <p:nvCxnSpPr>
          <p:cNvPr id="12" name="Connettore diritto 12">
            <a:extLst>
              <a:ext uri="{FF2B5EF4-FFF2-40B4-BE49-F238E27FC236}">
                <a16:creationId xmlns:a16="http://schemas.microsoft.com/office/drawing/2014/main" id="{1A30E2EA-E170-0BCB-6C97-0C16F53404CE}"/>
              </a:ext>
            </a:extLst>
          </p:cNvPr>
          <p:cNvCxnSpPr>
            <a:cxnSpLocks/>
          </p:cNvCxnSpPr>
          <p:nvPr/>
        </p:nvCxnSpPr>
        <p:spPr>
          <a:xfrm>
            <a:off x="1923609" y="1827953"/>
            <a:ext cx="226416" cy="0"/>
          </a:xfrm>
          <a:prstGeom prst="line">
            <a:avLst/>
          </a:prstGeom>
          <a:ln w="28575">
            <a:solidFill>
              <a:srgbClr val="3333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diritto 12">
            <a:extLst>
              <a:ext uri="{FF2B5EF4-FFF2-40B4-BE49-F238E27FC236}">
                <a16:creationId xmlns:a16="http://schemas.microsoft.com/office/drawing/2014/main" id="{35F350F7-DA5D-CFDD-587A-1A0B523CD944}"/>
              </a:ext>
            </a:extLst>
          </p:cNvPr>
          <p:cNvCxnSpPr>
            <a:cxnSpLocks/>
          </p:cNvCxnSpPr>
          <p:nvPr/>
        </p:nvCxnSpPr>
        <p:spPr>
          <a:xfrm>
            <a:off x="1923609" y="1675610"/>
            <a:ext cx="226416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diritto 12">
            <a:extLst>
              <a:ext uri="{FF2B5EF4-FFF2-40B4-BE49-F238E27FC236}">
                <a16:creationId xmlns:a16="http://schemas.microsoft.com/office/drawing/2014/main" id="{8D04B326-B152-4A38-1558-D5B8FF6639C6}"/>
              </a:ext>
            </a:extLst>
          </p:cNvPr>
          <p:cNvCxnSpPr>
            <a:cxnSpLocks/>
          </p:cNvCxnSpPr>
          <p:nvPr/>
        </p:nvCxnSpPr>
        <p:spPr>
          <a:xfrm>
            <a:off x="8030385" y="1817988"/>
            <a:ext cx="226416" cy="0"/>
          </a:xfrm>
          <a:prstGeom prst="line">
            <a:avLst/>
          </a:prstGeom>
          <a:ln w="28575">
            <a:solidFill>
              <a:srgbClr val="3333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diritto 12">
            <a:extLst>
              <a:ext uri="{FF2B5EF4-FFF2-40B4-BE49-F238E27FC236}">
                <a16:creationId xmlns:a16="http://schemas.microsoft.com/office/drawing/2014/main" id="{31096133-3041-1E99-189B-62F45F84A83F}"/>
              </a:ext>
            </a:extLst>
          </p:cNvPr>
          <p:cNvCxnSpPr>
            <a:cxnSpLocks/>
          </p:cNvCxnSpPr>
          <p:nvPr/>
        </p:nvCxnSpPr>
        <p:spPr>
          <a:xfrm>
            <a:off x="8030385" y="1665645"/>
            <a:ext cx="226416" cy="0"/>
          </a:xfrm>
          <a:prstGeom prst="line">
            <a:avLst/>
          </a:prstGeom>
          <a:ln w="28575">
            <a:solidFill>
              <a:srgbClr val="CC291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object 85">
            <a:extLst>
              <a:ext uri="{FF2B5EF4-FFF2-40B4-BE49-F238E27FC236}">
                <a16:creationId xmlns:a16="http://schemas.microsoft.com/office/drawing/2014/main" id="{0FF37CE2-9310-13F7-1B47-B6CE9990E82C}"/>
              </a:ext>
            </a:extLst>
          </p:cNvPr>
          <p:cNvSpPr txBox="1"/>
          <p:nvPr/>
        </p:nvSpPr>
        <p:spPr>
          <a:xfrm>
            <a:off x="4114992" y="1566897"/>
            <a:ext cx="792128" cy="316111"/>
          </a:xfrm>
          <a:prstGeom prst="rect">
            <a:avLst/>
          </a:prstGeom>
        </p:spPr>
        <p:txBody>
          <a:bodyPr vert="horz" wrap="square" lIns="0" tIns="26034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5"/>
              </a:spcBef>
            </a:pPr>
            <a:r>
              <a:rPr lang="it-IT" sz="900" spc="50" dirty="0">
                <a:latin typeface="Arial" panose="020B0604020202020204" pitchFamily="34" charset="0"/>
                <a:cs typeface="Arial" panose="020B0604020202020204" pitchFamily="34" charset="0"/>
              </a:rPr>
              <a:t>51/111</a:t>
            </a:r>
          </a:p>
          <a:p>
            <a:pPr marL="12700" algn="ctr">
              <a:spcBef>
                <a:spcPts val="105"/>
              </a:spcBef>
            </a:pPr>
            <a:r>
              <a:rPr lang="it-IT" sz="900" spc="50" dirty="0">
                <a:latin typeface="Arial" panose="020B0604020202020204" pitchFamily="34" charset="0"/>
                <a:cs typeface="Arial" panose="020B0604020202020204" pitchFamily="34" charset="0"/>
              </a:rPr>
              <a:t>67/96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D5D47E1B-0758-20CE-9DF0-5678EE8C6F31}"/>
              </a:ext>
            </a:extLst>
          </p:cNvPr>
          <p:cNvSpPr txBox="1"/>
          <p:nvPr/>
        </p:nvSpPr>
        <p:spPr>
          <a:xfrm>
            <a:off x="323917" y="6028390"/>
            <a:ext cx="781064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gend</a:t>
            </a:r>
          </a:p>
          <a:p>
            <a:pPr algn="just"/>
            <a:r>
              <a:rPr lang="en-GB" sz="18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I: confidence interval; HR: hazard ratio </a:t>
            </a:r>
            <a:endParaRPr lang="it-IT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D9F10C64-5817-D932-A5DB-F42623CDDC8C}"/>
              </a:ext>
            </a:extLst>
          </p:cNvPr>
          <p:cNvSpPr txBox="1"/>
          <p:nvPr/>
        </p:nvSpPr>
        <p:spPr>
          <a:xfrm>
            <a:off x="428262" y="270940"/>
            <a:ext cx="116325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Overall Survival from liver surgery according to timing of disease relapse. </a:t>
            </a:r>
          </a:p>
          <a:p>
            <a:pPr algn="ctr"/>
            <a:r>
              <a:rPr lang="en-GB" sz="18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ut-offs for early disease relapse of 6 months (A) and 12 months (B)</a:t>
            </a:r>
            <a:endParaRPr lang="it-IT" sz="16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1061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60b811f-c8de-45e8-90ad-44bc932f8bd3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FBE8EC5E9EC4444925F43078550D586" ma:contentTypeVersion="18" ma:contentTypeDescription="Create a new document." ma:contentTypeScope="" ma:versionID="9ddab805fb40a8f0b4be64b827d93c34">
  <xsd:schema xmlns:xsd="http://www.w3.org/2001/XMLSchema" xmlns:xs="http://www.w3.org/2001/XMLSchema" xmlns:p="http://schemas.microsoft.com/office/2006/metadata/properties" xmlns:ns3="060b811f-c8de-45e8-90ad-44bc932f8bd3" xmlns:ns4="ad7734cf-2957-41b2-b668-5c27808432ab" targetNamespace="http://schemas.microsoft.com/office/2006/metadata/properties" ma:root="true" ma:fieldsID="133cd33ee7d9d1e154df2284830ee811" ns3:_="" ns4:_="">
    <xsd:import namespace="060b811f-c8de-45e8-90ad-44bc932f8bd3"/>
    <xsd:import namespace="ad7734cf-2957-41b2-b668-5c27808432a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LengthInSeconds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earchPropertie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60b811f-c8de-45e8-90ad-44bc932f8bd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4" nillable="true" ma:displayName="Length (seconds)" ma:internalName="MediaLengthInSeconds" ma:readOnly="true">
      <xsd:simpleType>
        <xsd:restriction base="dms:Unknown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23" nillable="true" ma:displayName="_activity" ma:hidden="true" ma:internalName="_activity">
      <xsd:simpleType>
        <xsd:restriction base="dms:Note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5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7734cf-2957-41b2-b668-5c27808432ab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255CA67-4CCD-4011-A43E-11DB83A71D65}">
  <ds:schemaRefs>
    <ds:schemaRef ds:uri="http://www.w3.org/XML/1998/namespace"/>
    <ds:schemaRef ds:uri="060b811f-c8de-45e8-90ad-44bc932f8bd3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ad7734cf-2957-41b2-b668-5c27808432ab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363DBC3A-D0AD-4896-9C8D-AD6B1C0C84F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60b811f-c8de-45e8-90ad-44bc932f8bd3"/>
    <ds:schemaRef ds:uri="ad7734cf-2957-41b2-b668-5c27808432a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F1FE6AC-162E-456A-AA63-C2E4336EA70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650</TotalTime>
  <Words>128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 Maria Germani</dc:creator>
  <cp:lastModifiedBy>Marco Maria Germani</cp:lastModifiedBy>
  <cp:revision>14</cp:revision>
  <dcterms:created xsi:type="dcterms:W3CDTF">2023-09-05T16:30:57Z</dcterms:created>
  <dcterms:modified xsi:type="dcterms:W3CDTF">2024-01-03T09:42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FBE8EC5E9EC4444925F43078550D586</vt:lpwstr>
  </property>
</Properties>
</file>